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F00182-E671-4DE9-BB00-AAB248A355E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26161B-B006-49C4-B6AD-BACA653827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C07CD6-9403-45A3-AB2F-282D6CDCBBB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7E926C3-9718-4941-9F5C-E3BEE8B1AE9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11075D-3E67-4EB8-AF00-7425C36ADDD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1027FD-AB83-4102-B506-CF917709B77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CAA309F-9643-4744-875D-906B627DCCB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E6A61B-A4F6-4DFF-89A2-F9940DF651F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BC430A-8776-493C-8B9C-1FCA9CE471C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622956-0ECB-445B-9EE6-785A45A44D5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F1D25FC-263E-4B54-97D4-FA412138CB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1FBCDD-7A12-4D81-8A43-F191708B1F5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AE54975-A8B7-4A18-B6BF-37A413BAD494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28600" y="6674760"/>
            <a:ext cx="640080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Additional File 5. Alignment of McDGAT2 and DGAT2 polypeptides from other plant species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Sequences of DGAT2 are from the following species: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Oryze sativa (Os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(gi 50725740)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Arabidopsis thaliana (At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(gi 18409359),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Ricinus communis (Rc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(gi 255575255) 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Vernicia fordii (Vf)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(gi 86279636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762120" y="1523880"/>
            <a:ext cx="5333760" cy="4419360"/>
            <a:chOff x="762120" y="1523880"/>
            <a:chExt cx="5333760" cy="4419360"/>
          </a:xfrm>
        </p:grpSpPr>
        <p:pic>
          <p:nvPicPr>
            <p:cNvPr id="43" name="" descr=""/>
            <p:cNvPicPr/>
            <p:nvPr/>
          </p:nvPicPr>
          <p:blipFill>
            <a:blip r:embed="rId1"/>
            <a:srcRect l="0" t="25007" r="0" b="12518"/>
            <a:stretch/>
          </p:blipFill>
          <p:spPr>
            <a:xfrm>
              <a:off x="762120" y="1523880"/>
              <a:ext cx="5333760" cy="65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2"/>
            <a:srcRect l="0" t="25007" r="0" b="12518"/>
            <a:stretch/>
          </p:blipFill>
          <p:spPr>
            <a:xfrm>
              <a:off x="762120" y="2275560"/>
              <a:ext cx="5333760" cy="659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3"/>
            <a:srcRect l="0" t="25007" r="0" b="12518"/>
            <a:stretch/>
          </p:blipFill>
          <p:spPr>
            <a:xfrm>
              <a:off x="762120" y="3027240"/>
              <a:ext cx="5333760" cy="65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" descr=""/>
            <p:cNvPicPr/>
            <p:nvPr/>
          </p:nvPicPr>
          <p:blipFill>
            <a:blip r:embed="rId4"/>
            <a:srcRect l="0" t="25007" r="0" b="12518"/>
            <a:stretch/>
          </p:blipFill>
          <p:spPr>
            <a:xfrm>
              <a:off x="762120" y="3778920"/>
              <a:ext cx="5333760" cy="65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" descr=""/>
            <p:cNvPicPr/>
            <p:nvPr/>
          </p:nvPicPr>
          <p:blipFill>
            <a:blip r:embed="rId5"/>
            <a:srcRect l="0" t="25007" r="0" b="12518"/>
            <a:stretch/>
          </p:blipFill>
          <p:spPr>
            <a:xfrm>
              <a:off x="762120" y="4530600"/>
              <a:ext cx="5333760" cy="65916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" descr=""/>
            <p:cNvPicPr/>
            <p:nvPr/>
          </p:nvPicPr>
          <p:blipFill>
            <a:blip r:embed="rId6"/>
            <a:srcRect l="0" t="25007" r="18424" b="12518"/>
            <a:stretch/>
          </p:blipFill>
          <p:spPr>
            <a:xfrm>
              <a:off x="762120" y="5283720"/>
              <a:ext cx="4350960" cy="65952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0-25T02:27:16Z</dcterms:created>
  <dc:creator>pyang</dc:creator>
  <dc:description/>
  <dc:language>en-US</dc:language>
  <cp:lastModifiedBy>pyang</cp:lastModifiedBy>
  <dcterms:modified xsi:type="dcterms:W3CDTF">2010-10-25T04:35:21Z</dcterms:modified>
  <cp:revision>2</cp:revision>
  <dc:subject/>
  <dc:title>Slide 1</dc:title>
</cp:coreProperties>
</file>